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9" d="100"/>
          <a:sy n="79" d="100"/>
        </p:scale>
        <p:origin x="-87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F20AB8-10C4-5B45-B68F-8DE277429D1B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46B5CD1-FA0D-D048-B90D-DEAC7EF722AC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4620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88BAB04-4DEB-524F-81B7-38C3E11A436C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282B7B9-9FC2-7044-B4F8-1CD51791D561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4000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B0AB9FD-DE52-2544-9F50-479CE0E2C242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B9DD44E-297D-F04A-AB71-9AF0924C6890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7440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020039D-4A3F-734D-87C6-D1D1585D6646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BEA89DE-0B85-5B4C-A33E-CA750129FAD7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7055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6B700AF-2661-1544-9C4E-6A225A92857F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B773884-860D-8642-A7DA-769D1E5C7420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2181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8D7DEB1-45D4-C043-B557-A2950F00D3DF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AE5160F-018A-AD40-8484-0333C1E3EF12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5226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CFF0C65-795F-514B-92D8-3A716F7C9CBB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05ADEBB-15F5-B944-AE82-EAA774940EC0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5686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B64CCFC-3038-C64D-8445-7609F14A2B19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4C97702-7459-3D4A-8D0F-58F206AADCFE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6444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56CF4C4-933F-8E48-BB6C-9C34E92266AC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5014C69-545A-A74C-BE09-FDBD4FC260E1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2012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865BA36-D9C9-954C-896B-F16618DA2D1B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3852745-7140-F64E-A441-95420F29AD31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0303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smtClean="0"/>
              <a:t>Drag picture to placeholder or click icon to add</a:t>
            </a:r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CE0C25E-8C27-8349-BFE0-018814FE72B4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D648AE4-D1FA-D740-BDD6-89B555804F74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7988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fld id="{E82C74BC-DB90-534F-B057-32822B987876}" type="datetimeFigureOut">
              <a:rPr lang="de-DE"/>
              <a:pPr/>
              <a:t>29.07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6C481C17-115F-8549-B77D-8CE04297EDAF}" type="slidenum">
              <a:rPr lang="de-DE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CustomShape 1"/>
          <p:cNvSpPr/>
          <p:nvPr/>
        </p:nvSpPr>
        <p:spPr>
          <a:xfrm>
            <a:off x="29880" y="833966"/>
            <a:ext cx="1909440" cy="47448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 dirty="0" err="1">
                <a:solidFill>
                  <a:srgbClr val="000000"/>
                </a:solidFill>
                <a:latin typeface="Calibri"/>
              </a:rPr>
              <a:t>Genemark</a:t>
            </a:r>
            <a:r>
              <a:rPr lang="en-US" sz="1200" dirty="0" smtClean="0">
                <a:solidFill>
                  <a:srgbClr val="000000"/>
                </a:solidFill>
                <a:latin typeface="Calibri"/>
              </a:rPr>
              <a:t>-ET</a:t>
            </a:r>
            <a:endParaRPr dirty="0"/>
          </a:p>
        </p:txBody>
      </p:sp>
      <p:sp>
        <p:nvSpPr>
          <p:cNvPr id="125" name="CustomShape 2"/>
          <p:cNvSpPr/>
          <p:nvPr/>
        </p:nvSpPr>
        <p:spPr>
          <a:xfrm>
            <a:off x="2862360" y="688886"/>
            <a:ext cx="1909440" cy="51948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Tophat2</a:t>
            </a:r>
            <a:endParaRPr/>
          </a:p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(accepted.bam)</a:t>
            </a:r>
            <a:endParaRPr/>
          </a:p>
        </p:txBody>
      </p:sp>
      <p:sp>
        <p:nvSpPr>
          <p:cNvPr id="126" name="CustomShape 3"/>
          <p:cNvSpPr/>
          <p:nvPr/>
        </p:nvSpPr>
        <p:spPr>
          <a:xfrm>
            <a:off x="6705000" y="188846"/>
            <a:ext cx="1564560" cy="40392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RNA-Seq</a:t>
            </a:r>
            <a:endParaRPr/>
          </a:p>
        </p:txBody>
      </p:sp>
      <p:sp>
        <p:nvSpPr>
          <p:cNvPr id="127" name="CustomShape 4"/>
          <p:cNvSpPr/>
          <p:nvPr/>
        </p:nvSpPr>
        <p:spPr>
          <a:xfrm>
            <a:off x="6705000" y="1308806"/>
            <a:ext cx="1684440" cy="52092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Cufflinks</a:t>
            </a:r>
            <a:endParaRPr/>
          </a:p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(transcript.fasta)</a:t>
            </a:r>
            <a:endParaRPr/>
          </a:p>
        </p:txBody>
      </p:sp>
      <p:sp>
        <p:nvSpPr>
          <p:cNvPr id="128" name="CustomShape 5"/>
          <p:cNvSpPr/>
          <p:nvPr/>
        </p:nvSpPr>
        <p:spPr>
          <a:xfrm>
            <a:off x="3150000" y="2419766"/>
            <a:ext cx="1219320" cy="46872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 dirty="0">
                <a:solidFill>
                  <a:srgbClr val="000000"/>
                </a:solidFill>
                <a:latin typeface="Calibri"/>
              </a:rPr>
              <a:t>Augustus</a:t>
            </a:r>
            <a:endParaRPr dirty="0"/>
          </a:p>
        </p:txBody>
      </p:sp>
      <p:sp>
        <p:nvSpPr>
          <p:cNvPr id="129" name="CustomShape 6"/>
          <p:cNvSpPr/>
          <p:nvPr/>
        </p:nvSpPr>
        <p:spPr>
          <a:xfrm>
            <a:off x="4961520" y="2426246"/>
            <a:ext cx="1909440" cy="74916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GMAP</a:t>
            </a:r>
            <a:endParaRPr/>
          </a:p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(Mapping transcripts to genome)</a:t>
            </a:r>
            <a:endParaRPr/>
          </a:p>
        </p:txBody>
      </p:sp>
      <p:sp>
        <p:nvSpPr>
          <p:cNvPr id="130" name="CustomShape 7"/>
          <p:cNvSpPr/>
          <p:nvPr/>
        </p:nvSpPr>
        <p:spPr>
          <a:xfrm>
            <a:off x="6923880" y="2426246"/>
            <a:ext cx="1909440" cy="74916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PASA</a:t>
            </a:r>
            <a:endParaRPr/>
          </a:p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(Mapping transcripts to genome)</a:t>
            </a:r>
            <a:endParaRPr/>
          </a:p>
        </p:txBody>
      </p:sp>
      <p:sp>
        <p:nvSpPr>
          <p:cNvPr id="131" name="CustomShape 8"/>
          <p:cNvSpPr/>
          <p:nvPr/>
        </p:nvSpPr>
        <p:spPr>
          <a:xfrm>
            <a:off x="3021120" y="3629006"/>
            <a:ext cx="1663920" cy="42228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endParaRPr lang="en-US" sz="1600" dirty="0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</a:pPr>
            <a:r>
              <a:rPr lang="en-US" sz="1600" dirty="0" smtClean="0">
                <a:solidFill>
                  <a:srgbClr val="000000"/>
                </a:solidFill>
                <a:latin typeface="Calibri"/>
              </a:rPr>
              <a:t>EVM</a:t>
            </a:r>
            <a:endParaRPr dirty="0"/>
          </a:p>
          <a:p>
            <a:pPr algn="ctr">
              <a:lnSpc>
                <a:spcPct val="100000"/>
              </a:lnSpc>
            </a:pPr>
            <a:endParaRPr dirty="0"/>
          </a:p>
        </p:txBody>
      </p:sp>
      <p:sp>
        <p:nvSpPr>
          <p:cNvPr id="132" name="CustomShape 9"/>
          <p:cNvSpPr/>
          <p:nvPr/>
        </p:nvSpPr>
        <p:spPr>
          <a:xfrm rot="5400000">
            <a:off x="6010560" y="-643114"/>
            <a:ext cx="239400" cy="2714400"/>
          </a:xfrm>
          <a:prstGeom prst="curvedConnector2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33" name="CustomShape 10"/>
          <p:cNvSpPr/>
          <p:nvPr/>
        </p:nvSpPr>
        <p:spPr>
          <a:xfrm>
            <a:off x="4210200" y="1209086"/>
            <a:ext cx="2494080" cy="360360"/>
          </a:xfrm>
          <a:prstGeom prst="curvedConnector3">
            <a:avLst>
              <a:gd name="adj1" fmla="val 696"/>
            </a:avLst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34" name="CustomShape 11"/>
          <p:cNvSpPr/>
          <p:nvPr/>
        </p:nvSpPr>
        <p:spPr>
          <a:xfrm rot="16200000" flipH="1">
            <a:off x="576000" y="1395926"/>
            <a:ext cx="2507400" cy="2380680"/>
          </a:xfrm>
          <a:prstGeom prst="curvedConnector2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35" name="CustomShape 12"/>
          <p:cNvSpPr/>
          <p:nvPr/>
        </p:nvSpPr>
        <p:spPr>
          <a:xfrm rot="5400000">
            <a:off x="5915520" y="1947086"/>
            <a:ext cx="734400" cy="3192120"/>
          </a:xfrm>
          <a:prstGeom prst="curvedConnector2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36" name="CustomShape 13"/>
          <p:cNvSpPr/>
          <p:nvPr/>
        </p:nvSpPr>
        <p:spPr>
          <a:xfrm rot="5400000">
            <a:off x="5030640" y="2832326"/>
            <a:ext cx="542160" cy="1229760"/>
          </a:xfrm>
          <a:prstGeom prst="curvedConnector2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37" name="CustomShape 14"/>
          <p:cNvSpPr/>
          <p:nvPr/>
        </p:nvSpPr>
        <p:spPr>
          <a:xfrm rot="16200000" flipH="1">
            <a:off x="1394280" y="899486"/>
            <a:ext cx="1344600" cy="2164320"/>
          </a:xfrm>
          <a:prstGeom prst="curvedConnector2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38" name="CustomShape 15"/>
          <p:cNvSpPr/>
          <p:nvPr/>
        </p:nvSpPr>
        <p:spPr>
          <a:xfrm>
            <a:off x="3747240" y="1209086"/>
            <a:ext cx="12240" cy="120996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39" name="CustomShape 16"/>
          <p:cNvSpPr/>
          <p:nvPr/>
        </p:nvSpPr>
        <p:spPr>
          <a:xfrm flipH="1">
            <a:off x="6489360" y="1849526"/>
            <a:ext cx="589320" cy="56916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40" name="CustomShape 17"/>
          <p:cNvSpPr/>
          <p:nvPr/>
        </p:nvSpPr>
        <p:spPr>
          <a:xfrm>
            <a:off x="7759800" y="1830806"/>
            <a:ext cx="360" cy="56916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41" name="CustomShape 18"/>
          <p:cNvSpPr/>
          <p:nvPr/>
        </p:nvSpPr>
        <p:spPr>
          <a:xfrm>
            <a:off x="3747240" y="2889206"/>
            <a:ext cx="12240" cy="73944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42" name="CustomShape 19"/>
          <p:cNvSpPr/>
          <p:nvPr/>
        </p:nvSpPr>
        <p:spPr>
          <a:xfrm>
            <a:off x="1720800" y="1830806"/>
            <a:ext cx="1136160" cy="277560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none"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200" dirty="0" err="1" smtClean="0">
                <a:solidFill>
                  <a:srgbClr val="000000"/>
                </a:solidFill>
                <a:latin typeface="Calibri"/>
              </a:rPr>
              <a:t>Hintfile</a:t>
            </a:r>
            <a:endParaRPr dirty="0"/>
          </a:p>
        </p:txBody>
      </p:sp>
      <p:sp>
        <p:nvSpPr>
          <p:cNvPr id="143" name="CustomShape 20"/>
          <p:cNvSpPr/>
          <p:nvPr/>
        </p:nvSpPr>
        <p:spPr>
          <a:xfrm>
            <a:off x="3801240" y="1747646"/>
            <a:ext cx="1262520" cy="456480"/>
          </a:xfrm>
          <a:prstGeom prst="rect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Intron/Exon hints</a:t>
            </a:r>
            <a:endParaRPr/>
          </a:p>
          <a:p>
            <a:pPr>
              <a:lnSpc>
                <a:spcPct val="100000"/>
              </a:lnSpc>
            </a:pPr>
            <a:endParaRPr/>
          </a:p>
        </p:txBody>
      </p:sp>
      <p:sp>
        <p:nvSpPr>
          <p:cNvPr id="144" name="CustomShape 21"/>
          <p:cNvSpPr/>
          <p:nvPr/>
        </p:nvSpPr>
        <p:spPr>
          <a:xfrm>
            <a:off x="3179160" y="5897726"/>
            <a:ext cx="1310040" cy="62928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 dirty="0">
                <a:solidFill>
                  <a:srgbClr val="000000"/>
                </a:solidFill>
                <a:latin typeface="Calibri"/>
              </a:rPr>
              <a:t>Final gene </a:t>
            </a:r>
            <a:r>
              <a:rPr lang="en-US" sz="1200" dirty="0" smtClean="0">
                <a:solidFill>
                  <a:srgbClr val="000000"/>
                </a:solidFill>
                <a:latin typeface="Calibri"/>
              </a:rPr>
              <a:t>set</a:t>
            </a:r>
            <a:endParaRPr dirty="0"/>
          </a:p>
        </p:txBody>
      </p:sp>
      <p:sp>
        <p:nvSpPr>
          <p:cNvPr id="145" name="CustomShape 22"/>
          <p:cNvSpPr/>
          <p:nvPr/>
        </p:nvSpPr>
        <p:spPr>
          <a:xfrm>
            <a:off x="3782880" y="4076486"/>
            <a:ext cx="5760" cy="177696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46" name="CustomShape 23"/>
          <p:cNvSpPr/>
          <p:nvPr/>
        </p:nvSpPr>
        <p:spPr>
          <a:xfrm>
            <a:off x="4252320" y="4249286"/>
            <a:ext cx="1679040" cy="55944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Mask Repeat elements and Genic regions</a:t>
            </a:r>
            <a:endParaRPr/>
          </a:p>
        </p:txBody>
      </p:sp>
      <p:sp>
        <p:nvSpPr>
          <p:cNvPr id="147" name="CustomShape 24"/>
          <p:cNvSpPr/>
          <p:nvPr/>
        </p:nvSpPr>
        <p:spPr>
          <a:xfrm>
            <a:off x="5522400" y="4991606"/>
            <a:ext cx="1653840" cy="43632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Tophat2</a:t>
            </a:r>
            <a:endParaRPr/>
          </a:p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(accepted.bam)</a:t>
            </a:r>
            <a:endParaRPr/>
          </a:p>
        </p:txBody>
      </p:sp>
      <p:sp>
        <p:nvSpPr>
          <p:cNvPr id="148" name="CustomShape 25"/>
          <p:cNvSpPr/>
          <p:nvPr/>
        </p:nvSpPr>
        <p:spPr>
          <a:xfrm flipH="1">
            <a:off x="4489560" y="6212726"/>
            <a:ext cx="1031400" cy="36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49" name="CustomShape 26"/>
          <p:cNvSpPr/>
          <p:nvPr/>
        </p:nvSpPr>
        <p:spPr>
          <a:xfrm>
            <a:off x="3789360" y="4263326"/>
            <a:ext cx="462240" cy="279360"/>
          </a:xfrm>
          <a:prstGeom prst="curvedConnector3">
            <a:avLst>
              <a:gd name="adj1" fmla="val 311"/>
            </a:avLst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50" name="CustomShape 27"/>
          <p:cNvSpPr/>
          <p:nvPr/>
        </p:nvSpPr>
        <p:spPr>
          <a:xfrm rot="10800000" flipV="1">
            <a:off x="5917320" y="3729086"/>
            <a:ext cx="3013200" cy="773640"/>
          </a:xfrm>
          <a:prstGeom prst="curvedConnector3">
            <a:avLst>
              <a:gd name="adj1" fmla="val -104"/>
            </a:avLst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51" name="CustomShape 28"/>
          <p:cNvSpPr/>
          <p:nvPr/>
        </p:nvSpPr>
        <p:spPr>
          <a:xfrm>
            <a:off x="5522400" y="5854166"/>
            <a:ext cx="1684440" cy="65448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Transdecoder</a:t>
            </a:r>
            <a:endParaRPr/>
          </a:p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(Highly confident gene set)</a:t>
            </a:r>
            <a:endParaRPr/>
          </a:p>
        </p:txBody>
      </p:sp>
      <p:sp>
        <p:nvSpPr>
          <p:cNvPr id="152" name="CustomShape 29"/>
          <p:cNvSpPr/>
          <p:nvPr/>
        </p:nvSpPr>
        <p:spPr>
          <a:xfrm>
            <a:off x="4956480" y="4809086"/>
            <a:ext cx="564840" cy="398520"/>
          </a:xfrm>
          <a:prstGeom prst="curvedConnector3">
            <a:avLst>
              <a:gd name="adj1" fmla="val 2262"/>
            </a:avLst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53" name="CustomShape 30"/>
          <p:cNvSpPr/>
          <p:nvPr/>
        </p:nvSpPr>
        <p:spPr>
          <a:xfrm>
            <a:off x="7359840" y="5581286"/>
            <a:ext cx="1684440" cy="506880"/>
          </a:xfrm>
          <a:prstGeom prst="roundRect">
            <a:avLst>
              <a:gd name="adj" fmla="val 16667"/>
            </a:avLst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90000" tIns="45000" rIns="90000" bIns="45000" anchor="ctr"/>
          <a:lstStyle/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Cufflinks</a:t>
            </a:r>
            <a:endParaRPr/>
          </a:p>
          <a:p>
            <a:pPr algn="ctr"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Calibri"/>
              </a:rPr>
              <a:t>(transcript.fasta)</a:t>
            </a:r>
            <a:endParaRPr/>
          </a:p>
        </p:txBody>
      </p:sp>
      <p:sp>
        <p:nvSpPr>
          <p:cNvPr id="154" name="CustomShape 31"/>
          <p:cNvSpPr/>
          <p:nvPr/>
        </p:nvSpPr>
        <p:spPr>
          <a:xfrm>
            <a:off x="7176960" y="5210126"/>
            <a:ext cx="1024920" cy="370800"/>
          </a:xfrm>
          <a:prstGeom prst="curvedConnector2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55" name="CustomShape 32"/>
          <p:cNvSpPr/>
          <p:nvPr/>
        </p:nvSpPr>
        <p:spPr>
          <a:xfrm rot="5400000">
            <a:off x="7608960" y="5688206"/>
            <a:ext cx="192960" cy="994320"/>
          </a:xfrm>
          <a:prstGeom prst="curvedConnector2">
            <a:avLst/>
          </a:prstGeom>
          <a:ln>
            <a:tailEnd type="arrow" w="med" len="med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56" name="Line 33"/>
          <p:cNvSpPr/>
          <p:nvPr/>
        </p:nvSpPr>
        <p:spPr>
          <a:xfrm>
            <a:off x="8269920" y="391166"/>
            <a:ext cx="663840" cy="0"/>
          </a:xfrm>
          <a:prstGeom prst="line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  <p:sp>
        <p:nvSpPr>
          <p:cNvPr id="157" name="Line 34"/>
          <p:cNvSpPr/>
          <p:nvPr/>
        </p:nvSpPr>
        <p:spPr>
          <a:xfrm>
            <a:off x="8933760" y="391166"/>
            <a:ext cx="0" cy="3496320"/>
          </a:xfrm>
          <a:prstGeom prst="line">
            <a:avLst/>
          </a:prstGeom>
          <a:ln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sp>
    </p:spTree>
    <p:extLst>
      <p:ext uri="{BB962C8B-B14F-4D97-AF65-F5344CB8AC3E}">
        <p14:creationId xmlns:p14="http://schemas.microsoft.com/office/powerpoint/2010/main" val="2738895000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0</TotalTime>
  <Words>53</Words>
  <Application>Microsoft Office PowerPoint</Application>
  <PresentationFormat>Bildschirmpräsentation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Default Theme</vt:lpstr>
      <vt:lpstr>PowerPoint-Präsentation</vt:lpstr>
    </vt:vector>
  </TitlesOfParts>
  <Company>Bik-F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HUL SHARMA</dc:creator>
  <cp:lastModifiedBy>Marco Thines</cp:lastModifiedBy>
  <cp:revision>10</cp:revision>
  <cp:lastPrinted>2015-02-24T11:38:34Z</cp:lastPrinted>
  <dcterms:created xsi:type="dcterms:W3CDTF">2014-09-09T13:42:12Z</dcterms:created>
  <dcterms:modified xsi:type="dcterms:W3CDTF">2019-07-29T08:30:25Z</dcterms:modified>
</cp:coreProperties>
</file>